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4465" y="7045960"/>
            <a:ext cx="65258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9.Dynamics of alternative poly(A) site usage for the Os05g0509500 gene across 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oryza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 time course.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465" y="1211580"/>
            <a:ext cx="6480000" cy="525189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6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